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4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6" userDrawn="1">
          <p15:clr>
            <a:srgbClr val="A4A3A4"/>
          </p15:clr>
        </p15:guide>
        <p15:guide id="3" orient="horz" pos="3347" userDrawn="1">
          <p15:clr>
            <a:srgbClr val="A4A3A4"/>
          </p15:clr>
        </p15:guide>
        <p15:guide id="4" orient="horz" pos="240" userDrawn="1">
          <p15:clr>
            <a:srgbClr val="A4A3A4"/>
          </p15:clr>
        </p15:guide>
        <p15:guide id="5" orient="horz" pos="1192" userDrawn="1">
          <p15:clr>
            <a:srgbClr val="A4A3A4"/>
          </p15:clr>
        </p15:guide>
        <p15:guide id="6" pos="3997" userDrawn="1">
          <p15:clr>
            <a:srgbClr val="A4A3A4"/>
          </p15:clr>
        </p15:guide>
        <p15:guide id="7" pos="2523" userDrawn="1">
          <p15:clr>
            <a:srgbClr val="A4A3A4"/>
          </p15:clr>
        </p15:guide>
        <p15:guide id="8" pos="5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7" autoAdjust="0"/>
    <p:restoredTop sz="95756"/>
  </p:normalViewPr>
  <p:slideViewPr>
    <p:cSldViewPr snapToGrid="0" showGuides="1">
      <p:cViewPr varScale="1">
        <p:scale>
          <a:sx n="74" d="100"/>
          <a:sy n="74" d="100"/>
        </p:scale>
        <p:origin x="3280" y="184"/>
      </p:cViewPr>
      <p:guideLst>
        <p:guide orient="horz" pos="4866"/>
        <p:guide orient="horz" pos="3347"/>
        <p:guide orient="horz" pos="240"/>
        <p:guide orient="horz" pos="1192"/>
        <p:guide pos="3997"/>
        <p:guide pos="2523"/>
        <p:guide pos="5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DUARDO IGLESIAS GUTIERREZ" userId="88d24e39-c766-47dc-84d8-2c93e5e7d315" providerId="ADAL" clId="{C2D2567A-5C11-2446-8570-21EFAB6800F2}"/>
    <pc:docChg chg="undo custSel modSld">
      <pc:chgData name="EDUARDO IGLESIAS GUTIERREZ" userId="88d24e39-c766-47dc-84d8-2c93e5e7d315" providerId="ADAL" clId="{C2D2567A-5C11-2446-8570-21EFAB6800F2}" dt="2023-03-24T10:18:00.238" v="40" actId="1036"/>
      <pc:docMkLst>
        <pc:docMk/>
      </pc:docMkLst>
      <pc:sldChg chg="modSp mod">
        <pc:chgData name="EDUARDO IGLESIAS GUTIERREZ" userId="88d24e39-c766-47dc-84d8-2c93e5e7d315" providerId="ADAL" clId="{C2D2567A-5C11-2446-8570-21EFAB6800F2}" dt="2023-03-24T10:18:00.238" v="40" actId="1036"/>
        <pc:sldMkLst>
          <pc:docMk/>
          <pc:sldMk cId="2544633596" sldId="262"/>
        </pc:sldMkLst>
        <pc:spChg chg="mod">
          <ac:chgData name="EDUARDO IGLESIAS GUTIERREZ" userId="88d24e39-c766-47dc-84d8-2c93e5e7d315" providerId="ADAL" clId="{C2D2567A-5C11-2446-8570-21EFAB6800F2}" dt="2023-03-24T10:18:00.238" v="40" actId="1036"/>
          <ac:spMkLst>
            <pc:docMk/>
            <pc:sldMk cId="2544633596" sldId="262"/>
            <ac:spMk id="4" creationId="{AB1BD5C4-0495-C134-EBBF-53DE339DBBAE}"/>
          </ac:spMkLst>
        </pc:spChg>
        <pc:spChg chg="mod">
          <ac:chgData name="EDUARDO IGLESIAS GUTIERREZ" userId="88d24e39-c766-47dc-84d8-2c93e5e7d315" providerId="ADAL" clId="{C2D2567A-5C11-2446-8570-21EFAB6800F2}" dt="2023-03-24T10:18:00.238" v="40" actId="1036"/>
          <ac:spMkLst>
            <pc:docMk/>
            <pc:sldMk cId="2544633596" sldId="262"/>
            <ac:spMk id="5" creationId="{9E03DECC-E27C-D39B-B040-183247B227CA}"/>
          </ac:spMkLst>
        </pc:spChg>
        <pc:spChg chg="mod">
          <ac:chgData name="EDUARDO IGLESIAS GUTIERREZ" userId="88d24e39-c766-47dc-84d8-2c93e5e7d315" providerId="ADAL" clId="{C2D2567A-5C11-2446-8570-21EFAB6800F2}" dt="2023-03-24T10:18:00.238" v="40" actId="1036"/>
          <ac:spMkLst>
            <pc:docMk/>
            <pc:sldMk cId="2544633596" sldId="262"/>
            <ac:spMk id="7" creationId="{D53FFA84-AEC8-BDBF-DA4B-3A1B0E58F975}"/>
          </ac:spMkLst>
        </pc:spChg>
        <pc:spChg chg="mod">
          <ac:chgData name="EDUARDO IGLESIAS GUTIERREZ" userId="88d24e39-c766-47dc-84d8-2c93e5e7d315" providerId="ADAL" clId="{C2D2567A-5C11-2446-8570-21EFAB6800F2}" dt="2023-03-24T10:18:00.238" v="40" actId="1036"/>
          <ac:spMkLst>
            <pc:docMk/>
            <pc:sldMk cId="2544633596" sldId="262"/>
            <ac:spMk id="8" creationId="{7D6DC547-46DB-E22D-3F60-6B98DA5EDFB2}"/>
          </ac:spMkLst>
        </pc:spChg>
        <pc:picChg chg="mod">
          <ac:chgData name="EDUARDO IGLESIAS GUTIERREZ" userId="88d24e39-c766-47dc-84d8-2c93e5e7d315" providerId="ADAL" clId="{C2D2567A-5C11-2446-8570-21EFAB6800F2}" dt="2023-03-24T10:18:00.238" v="40" actId="1036"/>
          <ac:picMkLst>
            <pc:docMk/>
            <pc:sldMk cId="2544633596" sldId="262"/>
            <ac:picMk id="2" creationId="{D9D0AE8E-7870-E581-1B3D-5042AFE56463}"/>
          </ac:picMkLst>
        </pc:picChg>
        <pc:picChg chg="mod">
          <ac:chgData name="EDUARDO IGLESIAS GUTIERREZ" userId="88d24e39-c766-47dc-84d8-2c93e5e7d315" providerId="ADAL" clId="{C2D2567A-5C11-2446-8570-21EFAB6800F2}" dt="2023-03-24T10:18:00.238" v="40" actId="1036"/>
          <ac:picMkLst>
            <pc:docMk/>
            <pc:sldMk cId="2544633596" sldId="262"/>
            <ac:picMk id="6" creationId="{7495382D-1211-4BA3-CE3B-0D5B7C925C2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1339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106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4028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013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2438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93404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0187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8888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7255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096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9395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21D9D-255F-4A25-B96A-7EAC90F14F20}" type="datetimeFigureOut">
              <a:rPr lang="es-ES" smtClean="0"/>
              <a:t>9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9F640-1AA7-48A1-B0BB-A897FAFF7D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9414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3725F5C9-7636-847D-2892-586765E426EC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1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D9D0AE8E-7870-E581-1B3D-5042AFE564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961" t="14733" r="11433"/>
          <a:stretch/>
        </p:blipFill>
        <p:spPr>
          <a:xfrm>
            <a:off x="949574" y="861647"/>
            <a:ext cx="2083777" cy="2329923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D53FFA84-AEC8-BDBF-DA4B-3A1B0E58F975}"/>
              </a:ext>
            </a:extLst>
          </p:cNvPr>
          <p:cNvSpPr txBox="1"/>
          <p:nvPr/>
        </p:nvSpPr>
        <p:spPr>
          <a:xfrm rot="16200000">
            <a:off x="120926" y="1767201"/>
            <a:ext cx="1420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Shannon </a:t>
            </a:r>
            <a:r>
              <a:rPr lang="es-ES" sz="1000" b="1" dirty="0" err="1"/>
              <a:t>Index</a:t>
            </a:r>
            <a:endParaRPr lang="es-ES" sz="1000" b="1" dirty="0"/>
          </a:p>
        </p:txBody>
      </p:sp>
    </p:spTree>
    <p:extLst>
      <p:ext uri="{BB962C8B-B14F-4D97-AF65-F5344CB8AC3E}">
        <p14:creationId xmlns:p14="http://schemas.microsoft.com/office/powerpoint/2010/main" val="2544633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 descr="Gráfico, Diagrama&#10;&#10;Descripción generada automáticamente">
            <a:extLst>
              <a:ext uri="{FF2B5EF4-FFF2-40B4-BE49-F238E27FC236}">
                <a16:creationId xmlns:a16="http://schemas.microsoft.com/office/drawing/2014/main" id="{C90744A0-51F7-8806-B6E8-0FADB792D1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1" b="66077"/>
          <a:stretch/>
        </p:blipFill>
        <p:spPr>
          <a:xfrm>
            <a:off x="342003" y="6079085"/>
            <a:ext cx="6172200" cy="1921934"/>
          </a:xfrm>
          <a:prstGeom prst="rect">
            <a:avLst/>
          </a:prstGeom>
        </p:spPr>
      </p:pic>
      <p:pic>
        <p:nvPicPr>
          <p:cNvPr id="15" name="Imagen 14" descr="Gráfico, Diagrama&#10;&#10;Descripción generada automáticamente">
            <a:extLst>
              <a:ext uri="{FF2B5EF4-FFF2-40B4-BE49-F238E27FC236}">
                <a16:creationId xmlns:a16="http://schemas.microsoft.com/office/drawing/2014/main" id="{F88FF6D1-D56E-5FBC-0EC8-E749052CE1F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209" b="33988"/>
          <a:stretch/>
        </p:blipFill>
        <p:spPr>
          <a:xfrm>
            <a:off x="342003" y="3522136"/>
            <a:ext cx="6172200" cy="1921933"/>
          </a:xfrm>
          <a:prstGeom prst="rect">
            <a:avLst/>
          </a:prstGeom>
        </p:spPr>
      </p:pic>
      <p:pic>
        <p:nvPicPr>
          <p:cNvPr id="14" name="Imagen 13" descr="Gráfico, Diagrama&#10;&#10;Descripción generada automáticamente">
            <a:extLst>
              <a:ext uri="{FF2B5EF4-FFF2-40B4-BE49-F238E27FC236}">
                <a16:creationId xmlns:a16="http://schemas.microsoft.com/office/drawing/2014/main" id="{B2D75F39-70B0-AB0C-AD62-60D96BB984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808" b="2390"/>
          <a:stretch/>
        </p:blipFill>
        <p:spPr>
          <a:xfrm>
            <a:off x="342003" y="965189"/>
            <a:ext cx="6172200" cy="1921934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B729EB13-4F54-4FA9-B30F-6B0B5221F2EC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2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B2A2074D-7D35-99D2-B8EF-38717F147568}"/>
              </a:ext>
            </a:extLst>
          </p:cNvPr>
          <p:cNvSpPr txBox="1"/>
          <p:nvPr/>
        </p:nvSpPr>
        <p:spPr>
          <a:xfrm>
            <a:off x="2324561" y="2087035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82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5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35F52F5-D060-50FC-DB59-875B79D57173}"/>
              </a:ext>
            </a:extLst>
          </p:cNvPr>
          <p:cNvSpPr txBox="1"/>
          <p:nvPr/>
        </p:nvSpPr>
        <p:spPr>
          <a:xfrm>
            <a:off x="5338695" y="2087033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82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5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BC417B89-FE82-C5CB-7252-FD9ED4C51FAF}"/>
              </a:ext>
            </a:extLst>
          </p:cNvPr>
          <p:cNvSpPr txBox="1"/>
          <p:nvPr/>
        </p:nvSpPr>
        <p:spPr>
          <a:xfrm>
            <a:off x="2324559" y="4643971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64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7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924126BC-9AE1-CF43-3980-0483CBC9D4A6}"/>
              </a:ext>
            </a:extLst>
          </p:cNvPr>
          <p:cNvSpPr txBox="1"/>
          <p:nvPr/>
        </p:nvSpPr>
        <p:spPr>
          <a:xfrm>
            <a:off x="2324557" y="7175500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530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42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0BB8CB8-6AC2-840C-7183-CF25CA488524}"/>
              </a:ext>
            </a:extLst>
          </p:cNvPr>
          <p:cNvSpPr txBox="1"/>
          <p:nvPr/>
        </p:nvSpPr>
        <p:spPr>
          <a:xfrm>
            <a:off x="5338698" y="7175496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698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4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879A8940-6356-FF0E-CAAF-47185A055EB3}"/>
              </a:ext>
            </a:extLst>
          </p:cNvPr>
          <p:cNvSpPr txBox="1"/>
          <p:nvPr/>
        </p:nvSpPr>
        <p:spPr>
          <a:xfrm>
            <a:off x="5355631" y="4643965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549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34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5655D70-8766-D6A3-2D66-B01021D35562}"/>
              </a:ext>
            </a:extLst>
          </p:cNvPr>
          <p:cNvSpPr txBox="1"/>
          <p:nvPr/>
        </p:nvSpPr>
        <p:spPr>
          <a:xfrm>
            <a:off x="664887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A44A6C5-6E58-340D-0144-951A8ABBBEF0}"/>
              </a:ext>
            </a:extLst>
          </p:cNvPr>
          <p:cNvSpPr txBox="1"/>
          <p:nvPr/>
        </p:nvSpPr>
        <p:spPr>
          <a:xfrm>
            <a:off x="3837148" y="566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4192F3A-CDB8-64AB-2991-3ED7CD4F968E}"/>
              </a:ext>
            </a:extLst>
          </p:cNvPr>
          <p:cNvSpPr txBox="1"/>
          <p:nvPr/>
        </p:nvSpPr>
        <p:spPr>
          <a:xfrm>
            <a:off x="664883" y="31483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D31E2E8-2142-05DC-21CA-A4BAB36E7D32}"/>
              </a:ext>
            </a:extLst>
          </p:cNvPr>
          <p:cNvSpPr txBox="1"/>
          <p:nvPr/>
        </p:nvSpPr>
        <p:spPr>
          <a:xfrm>
            <a:off x="3837144" y="31483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F98D1D4-8F86-E828-D260-B4AFC3FF3F3E}"/>
              </a:ext>
            </a:extLst>
          </p:cNvPr>
          <p:cNvSpPr txBox="1"/>
          <p:nvPr/>
        </p:nvSpPr>
        <p:spPr>
          <a:xfrm>
            <a:off x="664879" y="57137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780FDF9F-B9F0-2A92-F725-541538168F42}"/>
              </a:ext>
            </a:extLst>
          </p:cNvPr>
          <p:cNvSpPr txBox="1"/>
          <p:nvPr/>
        </p:nvSpPr>
        <p:spPr>
          <a:xfrm>
            <a:off x="3837140" y="571374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158101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E4BE53AA-A24F-178F-F23B-35CFC80CDD7F}"/>
              </a:ext>
            </a:extLst>
          </p:cNvPr>
          <p:cNvSpPr txBox="1"/>
          <p:nvPr/>
        </p:nvSpPr>
        <p:spPr>
          <a:xfrm>
            <a:off x="304932" y="8884508"/>
            <a:ext cx="2967479" cy="369332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s-ES" b="1" dirty="0" err="1">
                <a:latin typeface="Arial"/>
                <a:cs typeface="Arial"/>
              </a:rPr>
              <a:t>Supplementary</a:t>
            </a:r>
            <a:r>
              <a:rPr lang="es-ES" b="1" dirty="0">
                <a:latin typeface="Arial"/>
                <a:cs typeface="Arial"/>
              </a:rPr>
              <a:t> Figure S3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 descr="Forma&#10;&#10;Descripción generada automáticamente con confianza media">
            <a:extLst>
              <a:ext uri="{FF2B5EF4-FFF2-40B4-BE49-F238E27FC236}">
                <a16:creationId xmlns:a16="http://schemas.microsoft.com/office/drawing/2014/main" id="{BA124EBA-2453-09CD-EFF3-C40BC56FB8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44"/>
          <a:stretch/>
        </p:blipFill>
        <p:spPr>
          <a:xfrm>
            <a:off x="638321" y="506878"/>
            <a:ext cx="2589389" cy="2125285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59146FB2-0651-25F0-4250-C9FB3C91C066}"/>
              </a:ext>
            </a:extLst>
          </p:cNvPr>
          <p:cNvSpPr txBox="1"/>
          <p:nvPr/>
        </p:nvSpPr>
        <p:spPr>
          <a:xfrm rot="16200000">
            <a:off x="-341095" y="1118037"/>
            <a:ext cx="14771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High-</a:t>
            </a:r>
            <a:r>
              <a:rPr lang="es-ES" sz="1000" b="1" dirty="0" err="1"/>
              <a:t>fibre</a:t>
            </a:r>
            <a:r>
              <a:rPr lang="es-ES" sz="1000" b="1" dirty="0"/>
              <a:t> </a:t>
            </a:r>
            <a:r>
              <a:rPr lang="es-ES" sz="1000" b="1" dirty="0" err="1"/>
              <a:t>foods</a:t>
            </a:r>
            <a:r>
              <a:rPr lang="es-ES" sz="1000" b="1" dirty="0"/>
              <a:t> </a:t>
            </a:r>
            <a:r>
              <a:rPr lang="es-ES" sz="1000" b="1" dirty="0" err="1"/>
              <a:t>intake</a:t>
            </a:r>
            <a:r>
              <a:rPr lang="es-ES" sz="1000" b="1" dirty="0"/>
              <a:t> </a:t>
            </a:r>
            <a:r>
              <a:rPr lang="es-ES" sz="1000" b="1" dirty="0" err="1"/>
              <a:t>before</a:t>
            </a:r>
            <a:r>
              <a:rPr lang="es-ES" sz="1000" b="1" dirty="0"/>
              <a:t> </a:t>
            </a:r>
            <a:r>
              <a:rPr lang="es-ES" sz="1000" b="1" dirty="0" err="1"/>
              <a:t>competition</a:t>
            </a:r>
            <a:r>
              <a:rPr lang="es-ES" sz="1000" b="1" dirty="0"/>
              <a:t> (</a:t>
            </a:r>
            <a:r>
              <a:rPr lang="es-ES" sz="1000" b="1" dirty="0" err="1"/>
              <a:t>servings</a:t>
            </a:r>
            <a:r>
              <a:rPr lang="es-ES" sz="1000" b="1" dirty="0"/>
              <a:t>/</a:t>
            </a:r>
            <a:r>
              <a:rPr lang="es-ES" sz="1000" b="1" dirty="0" err="1"/>
              <a:t>week</a:t>
            </a:r>
            <a:r>
              <a:rPr lang="es-ES" sz="1000" b="1" dirty="0"/>
              <a:t>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B17AD65-AD1E-73B6-FA88-A6A004E44320}"/>
              </a:ext>
            </a:extLst>
          </p:cNvPr>
          <p:cNvSpPr txBox="1"/>
          <p:nvPr/>
        </p:nvSpPr>
        <p:spPr>
          <a:xfrm>
            <a:off x="2172161" y="1739139"/>
            <a:ext cx="7742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/>
              <a:t>R</a:t>
            </a:r>
            <a:r>
              <a:rPr lang="es-ES" sz="800" baseline="30000" dirty="0"/>
              <a:t>2</a:t>
            </a:r>
            <a:r>
              <a:rPr lang="es-ES" sz="800" dirty="0"/>
              <a:t>=0.919</a:t>
            </a:r>
          </a:p>
          <a:p>
            <a:r>
              <a:rPr lang="es-ES" sz="800" dirty="0"/>
              <a:t>p-</a:t>
            </a:r>
            <a:r>
              <a:rPr lang="es-ES" sz="800" dirty="0" err="1"/>
              <a:t>value</a:t>
            </a:r>
            <a:r>
              <a:rPr lang="es-ES" sz="800" dirty="0"/>
              <a:t>=0.001</a:t>
            </a:r>
          </a:p>
        </p:txBody>
      </p:sp>
    </p:spTree>
    <p:extLst>
      <p:ext uri="{BB962C8B-B14F-4D97-AF65-F5344CB8AC3E}">
        <p14:creationId xmlns:p14="http://schemas.microsoft.com/office/powerpoint/2010/main" val="2693918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8</TotalTime>
  <Words>55</Words>
  <Application>Microsoft Macintosh PowerPoint</Application>
  <PresentationFormat>A4 (210 x 297 mm)</PresentationFormat>
  <Paragraphs>25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TOMAS ZAPICO</dc:creator>
  <cp:lastModifiedBy>EDUARDO IGLESIAS GUTIERREZ</cp:lastModifiedBy>
  <cp:revision>63</cp:revision>
  <dcterms:created xsi:type="dcterms:W3CDTF">2022-04-27T14:09:00Z</dcterms:created>
  <dcterms:modified xsi:type="dcterms:W3CDTF">2024-02-09T13:36:43Z</dcterms:modified>
</cp:coreProperties>
</file>